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203381-A8C3-4458-99B0-B6F9B3CFDEB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7BD880-05C5-4EA9-BB2A-74F5D701862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AB17C3-97DD-43C0-9D7A-C2228EC3EDE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8401ED-F916-4835-9FF8-224825B12D1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9E4616-5170-4216-81ED-CA56F135F4B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EA9562-1F78-4B81-9AB7-F795D7A66C2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725931-0909-41B6-BFA8-360875B8707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6A6A16-B35D-47F6-B98B-F7DC84B30FA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387C07-0530-4BD2-B285-C636E6D0AD2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085C1E-FC84-41C0-9ADD-3D7AB5DBBF8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8AE502-48E9-4FB1-9F0E-55FF9E943F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30722D-DD30-425F-A60F-03D2F6DED19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7F69F1D-8D20-49FF-B8AF-FC346C655B53}" type="slidenum">
              <a:rPr b="0" lang="en-GB" sz="14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24"/>
          <p:cNvSpPr/>
          <p:nvPr/>
        </p:nvSpPr>
        <p:spPr>
          <a:xfrm>
            <a:off x="862560" y="849240"/>
            <a:ext cx="2221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宋体"/>
              </a:rPr>
              <a:t>Supplement Tabl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785880" y="4572000"/>
          <a:ext cx="2643120" cy="1874880"/>
        </p:xfrm>
        <a:graphic>
          <a:graphicData uri="http://schemas.openxmlformats.org/drawingml/2006/table">
            <a:tbl>
              <a:tblPr/>
              <a:tblGrid>
                <a:gridCol w="1228680"/>
                <a:gridCol w="1414440"/>
              </a:tblGrid>
              <a:tr h="26820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Gen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Cat. No.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820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ALP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QT0021158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676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BMP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QT0001254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856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Osteocalci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QT0023277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820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Osterix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QT0021351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820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runx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QT0002051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676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18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QT0019936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43" name=""/>
          <p:cNvGraphicFramePr/>
          <p:nvPr/>
        </p:nvGraphicFramePr>
        <p:xfrm>
          <a:off x="785880" y="1571760"/>
          <a:ext cx="4513320" cy="1689120"/>
        </p:xfrm>
        <a:graphic>
          <a:graphicData uri="http://schemas.openxmlformats.org/drawingml/2006/table">
            <a:tbl>
              <a:tblPr/>
              <a:tblGrid>
                <a:gridCol w="600120"/>
                <a:gridCol w="600120"/>
                <a:gridCol w="598320"/>
                <a:gridCol w="857160"/>
                <a:gridCol w="1857600"/>
              </a:tblGrid>
              <a:tr h="281160"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Bef>
                          <a:spcPts val="1199"/>
                        </a:spcBef>
                        <a:spcAft>
                          <a:spcPts val="11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I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Bef>
                          <a:spcPts val="1199"/>
                        </a:spcBef>
                        <a:spcAft>
                          <a:spcPts val="11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Ag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Bef>
                          <a:spcPts val="1199"/>
                        </a:spcBef>
                        <a:spcAft>
                          <a:spcPts val="11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Sex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Bef>
                          <a:spcPts val="1199"/>
                        </a:spcBef>
                        <a:spcAft>
                          <a:spcPts val="11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Artery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Bef>
                          <a:spcPts val="1199"/>
                        </a:spcBef>
                        <a:spcAft>
                          <a:spcPts val="11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Descrip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2240"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Bef>
                          <a:spcPts val="1199"/>
                        </a:spcBef>
                        <a:spcAft>
                          <a:spcPts val="11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Bef>
                          <a:spcPts val="1199"/>
                        </a:spcBef>
                        <a:spcAft>
                          <a:spcPts val="11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3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Bef>
                          <a:spcPts val="1199"/>
                        </a:spcBef>
                        <a:spcAft>
                          <a:spcPts val="11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Bef>
                          <a:spcPts val="1199"/>
                        </a:spcBef>
                        <a:spcAft>
                          <a:spcPts val="11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T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Bef>
                          <a:spcPts val="1199"/>
                        </a:spcBef>
                        <a:spcAft>
                          <a:spcPts val="11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Norma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1160"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Bef>
                          <a:spcPts val="1199"/>
                        </a:spcBef>
                        <a:spcAft>
                          <a:spcPts val="11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Bef>
                          <a:spcPts val="1199"/>
                        </a:spcBef>
                        <a:spcAft>
                          <a:spcPts val="11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3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Bef>
                          <a:spcPts val="1199"/>
                        </a:spcBef>
                        <a:spcAft>
                          <a:spcPts val="11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F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Bef>
                          <a:spcPts val="1199"/>
                        </a:spcBef>
                        <a:spcAft>
                          <a:spcPts val="11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T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Bef>
                          <a:spcPts val="1199"/>
                        </a:spcBef>
                        <a:spcAft>
                          <a:spcPts val="11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Norma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1160"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Bef>
                          <a:spcPts val="1199"/>
                        </a:spcBef>
                        <a:spcAft>
                          <a:spcPts val="11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Bef>
                          <a:spcPts val="1199"/>
                        </a:spcBef>
                        <a:spcAft>
                          <a:spcPts val="11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3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Bef>
                          <a:spcPts val="1199"/>
                        </a:spcBef>
                        <a:spcAft>
                          <a:spcPts val="11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F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Bef>
                          <a:spcPts val="1199"/>
                        </a:spcBef>
                        <a:spcAft>
                          <a:spcPts val="11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T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Bef>
                          <a:spcPts val="1199"/>
                        </a:spcBef>
                        <a:spcAft>
                          <a:spcPts val="11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Intimal hyperplasi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2240"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Bef>
                          <a:spcPts val="1199"/>
                        </a:spcBef>
                        <a:spcAft>
                          <a:spcPts val="11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Bef>
                          <a:spcPts val="1199"/>
                        </a:spcBef>
                        <a:spcAft>
                          <a:spcPts val="11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5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Bef>
                          <a:spcPts val="1199"/>
                        </a:spcBef>
                        <a:spcAft>
                          <a:spcPts val="11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F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Bef>
                          <a:spcPts val="1199"/>
                        </a:spcBef>
                        <a:spcAft>
                          <a:spcPts val="11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T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Bef>
                          <a:spcPts val="1199"/>
                        </a:spcBef>
                        <a:spcAft>
                          <a:spcPts val="11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Intimal hyperplasi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1160"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Bef>
                          <a:spcPts val="1199"/>
                        </a:spcBef>
                        <a:spcAft>
                          <a:spcPts val="11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Bef>
                          <a:spcPts val="1199"/>
                        </a:spcBef>
                        <a:spcAft>
                          <a:spcPts val="11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7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Bef>
                          <a:spcPts val="1199"/>
                        </a:spcBef>
                        <a:spcAft>
                          <a:spcPts val="11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Bef>
                          <a:spcPts val="1199"/>
                        </a:spcBef>
                        <a:spcAft>
                          <a:spcPts val="11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T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 algn="ctr">
                        <a:lnSpc>
                          <a:spcPct val="150000"/>
                        </a:lnSpc>
                        <a:spcBef>
                          <a:spcPts val="1199"/>
                        </a:spcBef>
                        <a:spcAft>
                          <a:spcPts val="1199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Intimal hyperplasi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4" name="Text Box 24"/>
          <p:cNvSpPr/>
          <p:nvPr/>
        </p:nvSpPr>
        <p:spPr>
          <a:xfrm>
            <a:off x="932400" y="4140360"/>
            <a:ext cx="2221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宋体"/>
              </a:rPr>
              <a:t>Supplement Table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5" name=""/>
          <p:cNvGraphicFramePr/>
          <p:nvPr/>
        </p:nvGraphicFramePr>
        <p:xfrm>
          <a:off x="809640" y="4541760"/>
          <a:ext cx="2619360" cy="1928880"/>
        </p:xfrm>
        <a:graphic>
          <a:graphicData uri="http://schemas.openxmlformats.org/drawingml/2006/table">
            <a:tbl>
              <a:tblPr/>
              <a:tblGrid>
                <a:gridCol w="2619360"/>
              </a:tblGrid>
              <a:tr h="19288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6" name="TextBox 8"/>
          <p:cNvSpPr/>
          <p:nvPr/>
        </p:nvSpPr>
        <p:spPr>
          <a:xfrm>
            <a:off x="772920" y="6599160"/>
            <a:ext cx="2498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Details of primers used for  qPCR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9"/>
          <p:cNvSpPr/>
          <p:nvPr/>
        </p:nvSpPr>
        <p:spPr>
          <a:xfrm>
            <a:off x="842760" y="3348000"/>
            <a:ext cx="2952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Details of patients used for  cell isolation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0-13T07:40:14Z</dcterms:created>
  <dc:creator>Yvonne </dc:creator>
  <dc:description/>
  <dc:language>en-US</dc:language>
  <cp:lastModifiedBy>MDSSSYA2</cp:lastModifiedBy>
  <dcterms:modified xsi:type="dcterms:W3CDTF">2011-07-18T09:24:35Z</dcterms:modified>
  <cp:revision>7</cp:revision>
  <dc:subject/>
  <dc:title>Slide 1</dc:title>
</cp:coreProperties>
</file>